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23"/>
  </p:notesMasterIdLst>
  <p:handoutMasterIdLst>
    <p:handoutMasterId r:id="rId24"/>
  </p:handoutMasterIdLst>
  <p:sldIdLst>
    <p:sldId id="297" r:id="rId2"/>
    <p:sldId id="298" r:id="rId3"/>
    <p:sldId id="303" r:id="rId4"/>
    <p:sldId id="296" r:id="rId5"/>
    <p:sldId id="300" r:id="rId6"/>
    <p:sldId id="304" r:id="rId7"/>
    <p:sldId id="290" r:id="rId8"/>
    <p:sldId id="302" r:id="rId9"/>
    <p:sldId id="306" r:id="rId10"/>
    <p:sldId id="305" r:id="rId11"/>
    <p:sldId id="292" r:id="rId12"/>
    <p:sldId id="259" r:id="rId13"/>
    <p:sldId id="262" r:id="rId14"/>
    <p:sldId id="263" r:id="rId15"/>
    <p:sldId id="264" r:id="rId16"/>
    <p:sldId id="266" r:id="rId17"/>
    <p:sldId id="267" r:id="rId18"/>
    <p:sldId id="307" r:id="rId19"/>
    <p:sldId id="271" r:id="rId20"/>
    <p:sldId id="272" r:id="rId21"/>
    <p:sldId id="293" r:id="rId2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9" d="100"/>
          <a:sy n="69" d="100"/>
        </p:scale>
        <p:origin x="564" y="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viewProps" Target="viewProps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handoutMaster" Target="handoutMasters/handoutMaster1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notesMaster" Target="notesMasters/notesMaster1.xml"/><Relationship Id="rId28" Type="http://schemas.openxmlformats.org/officeDocument/2006/relationships/tableStyles" Target="tableStyle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theme" Target="theme/them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6A8579-ED5F-47C3-9133-2D233C550455}" type="datetimeFigureOut">
              <a:rPr lang="en-IN" smtClean="0"/>
              <a:t>26-11-2025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CA83F47-1558-4145-BCC9-4A463D90E94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783332506"/>
      </p:ext>
    </p:extLst>
  </p:cSld>
  <p:clrMap bg1="lt1" tx1="dk1" bg2="lt2" tx2="dk2" accent1="accent1" accent2="accent2" accent3="accent3" accent4="accent4" accent5="accent5" accent6="accent6" hlink="hlink" folHlink="folHlink"/>
  <p:hf hdr="0" ftr="0" dt="0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6E0E4A3-6ED7-4A0A-9E1D-C981EA5BFD35}" type="datetimeFigureOut">
              <a:rPr lang="en-IN" smtClean="0"/>
              <a:t>26-11-2025</a:t>
            </a:fld>
            <a:endParaRPr lang="en-IN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IN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F318BE6-F3DF-498C-8DC9-215BBE3CAD27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308334042"/>
      </p:ext>
    </p:extLst>
  </p:cSld>
  <p:clrMap bg1="lt1" tx1="dk1" bg2="lt2" tx2="dk2" accent1="accent1" accent2="accent2" accent3="accent3" accent4="accent4" accent5="accent5" accent6="accent6" hlink="hlink" folHlink="folHlink"/>
  <p:hf hdr="0" ftr="0" dt="0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D3EAE8-D85D-4042-8110-79B6758E9C84}" type="datetime1">
              <a:rPr lang="en-IN" smtClean="0"/>
              <a:t>26-11-202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05F05F-5AFD-4104-8603-F9D0AE6173F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3556979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00E916-635E-4189-AB0C-A1A38D0E0B0E}" type="datetime1">
              <a:rPr lang="en-IN" smtClean="0"/>
              <a:t>26-11-202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05F05F-5AFD-4104-8603-F9D0AE6173F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1363885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7A8AA1-F1F9-4DC9-897B-FCC1D3373F57}" type="datetime1">
              <a:rPr lang="en-IN" smtClean="0"/>
              <a:t>26-11-202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05F05F-5AFD-4104-8603-F9D0AE6173F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5634495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7EAA91-F69A-4437-A8A3-3A66FD9ADCB9}" type="datetime1">
              <a:rPr lang="en-IN" smtClean="0"/>
              <a:t>26-11-202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05F05F-5AFD-4104-8603-F9D0AE6173F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963449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1CE244-A499-48F2-A20F-817CDC553003}" type="datetime1">
              <a:rPr lang="en-IN" smtClean="0"/>
              <a:t>26-11-202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05F05F-5AFD-4104-8603-F9D0AE6173F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0608423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6AE9E5-FF9F-42B1-B61D-DBBC9CF2CC7D}" type="datetime1">
              <a:rPr lang="en-IN" smtClean="0"/>
              <a:t>26-11-2025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05F05F-5AFD-4104-8603-F9D0AE6173F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2492511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D276BF-0561-4B0D-A0D9-B6559E0FEDF0}" type="datetime1">
              <a:rPr lang="en-IN" smtClean="0"/>
              <a:t>26-11-2025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05F05F-5AFD-4104-8603-F9D0AE6173F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8735570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1F837A-1E88-48E1-9DF1-F351D8A2AADE}" type="datetime1">
              <a:rPr lang="en-IN" smtClean="0"/>
              <a:t>26-11-2025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05F05F-5AFD-4104-8603-F9D0AE6173F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5216319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EF2AB6-0339-4A56-BA31-78A7A5EDA103}" type="datetime1">
              <a:rPr lang="en-IN" smtClean="0"/>
              <a:t>26-11-2025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05F05F-5AFD-4104-8603-F9D0AE6173F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041263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BC66B9-3708-4BB5-8CCF-BD62FF95AE2F}" type="datetime1">
              <a:rPr lang="en-IN" smtClean="0"/>
              <a:t>26-11-2025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05F05F-5AFD-4104-8603-F9D0AE6173F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5898966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F8FB4A-2CD8-48E9-BFA1-B865E0C9A5E1}" type="datetime1">
              <a:rPr lang="en-IN" smtClean="0"/>
              <a:t>26-11-2025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05F05F-5AFD-4104-8603-F9D0AE6173F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823121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CEC713-4307-4785-830D-7C8186395389}" type="datetime1">
              <a:rPr lang="en-IN" smtClean="0"/>
              <a:t>26-11-202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05F05F-5AFD-4104-8603-F9D0AE6173F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6053095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hdr="0" ftr="0" dt="0"/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1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7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7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7.xml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jpe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Number Placeholder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05F05F-5AFD-4104-8603-F9D0AE6173F3}" type="slidenum">
              <a:rPr lang="en-IN" smtClean="0"/>
              <a:t>1</a:t>
            </a:fld>
            <a:endParaRPr lang="en-IN"/>
          </a:p>
        </p:txBody>
      </p:sp>
      <p:sp>
        <p:nvSpPr>
          <p:cNvPr id="3" name="TextBox 2"/>
          <p:cNvSpPr txBox="1"/>
          <p:nvPr/>
        </p:nvSpPr>
        <p:spPr>
          <a:xfrm>
            <a:off x="5044444" y="393458"/>
            <a:ext cx="27965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asthali</a:t>
            </a:r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Control (embryo)</a:t>
            </a:r>
            <a:endParaRPr lang="en-IN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14398" y="1020779"/>
            <a:ext cx="10635917" cy="5139389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6115369" y="2705737"/>
            <a:ext cx="20966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No Peak @ RT-32.36</a:t>
            </a:r>
            <a:endParaRPr lang="en-IN" dirty="0"/>
          </a:p>
        </p:txBody>
      </p:sp>
      <p:sp>
        <p:nvSpPr>
          <p:cNvPr id="7" name="Rectangle 6"/>
          <p:cNvSpPr/>
          <p:nvPr/>
        </p:nvSpPr>
        <p:spPr>
          <a:xfrm>
            <a:off x="914398" y="947956"/>
            <a:ext cx="11056692" cy="5478011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01355530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Number Placeholder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05F05F-5AFD-4104-8603-F9D0AE6173F3}" type="slidenum">
              <a:rPr lang="en-IN" smtClean="0"/>
              <a:t>10</a:t>
            </a:fld>
            <a:endParaRPr lang="en-IN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86862" y="901884"/>
            <a:ext cx="10110308" cy="5447635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4834106" y="274410"/>
            <a:ext cx="1197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usaMA2</a:t>
            </a:r>
            <a:endParaRPr lang="en-IN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4523155" y="2983170"/>
            <a:ext cx="181966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lavanols</a:t>
            </a:r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n-US" sz="14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Quercitin</a:t>
            </a:r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</a:p>
        </p:txBody>
      </p:sp>
      <p:sp>
        <p:nvSpPr>
          <p:cNvPr id="6" name="Rectangle 5"/>
          <p:cNvSpPr/>
          <p:nvPr/>
        </p:nvSpPr>
        <p:spPr>
          <a:xfrm>
            <a:off x="1086862" y="636144"/>
            <a:ext cx="10143776" cy="5902768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7" name="Rectangle 6"/>
          <p:cNvSpPr/>
          <p:nvPr/>
        </p:nvSpPr>
        <p:spPr>
          <a:xfrm>
            <a:off x="5066163" y="3378941"/>
            <a:ext cx="733647" cy="547480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100919242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71580" y="892120"/>
            <a:ext cx="9020466" cy="5189703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2929377" y="1211202"/>
            <a:ext cx="181966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lavanols</a:t>
            </a:r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n-US" sz="14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Quercitin</a:t>
            </a:r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</a:p>
        </p:txBody>
      </p:sp>
      <p:sp>
        <p:nvSpPr>
          <p:cNvPr id="2" name="Slide Number Placeholder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05F05F-5AFD-4104-8603-F9D0AE6173F3}" type="slidenum">
              <a:rPr lang="en-IN" smtClean="0"/>
              <a:t>11</a:t>
            </a:fld>
            <a:endParaRPr lang="en-IN"/>
          </a:p>
        </p:txBody>
      </p:sp>
      <p:sp>
        <p:nvSpPr>
          <p:cNvPr id="7" name="Rectangle 6"/>
          <p:cNvSpPr/>
          <p:nvPr/>
        </p:nvSpPr>
        <p:spPr>
          <a:xfrm>
            <a:off x="1634312" y="815474"/>
            <a:ext cx="9295002" cy="5540876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8" name="TextBox 7"/>
          <p:cNvSpPr txBox="1"/>
          <p:nvPr/>
        </p:nvSpPr>
        <p:spPr>
          <a:xfrm>
            <a:off x="4994376" y="345184"/>
            <a:ext cx="137409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0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usaMA2 </a:t>
            </a:r>
            <a:endParaRPr lang="en-IN" sz="20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8176971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35603" y="1037100"/>
            <a:ext cx="9169364" cy="5684375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2403881" y="1731564"/>
            <a:ext cx="127740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aempherol</a:t>
            </a:r>
            <a:endParaRPr lang="en-US" sz="16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Slide Number Placeholder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05F05F-5AFD-4104-8603-F9D0AE6173F3}" type="slidenum">
              <a:rPr lang="en-IN" smtClean="0"/>
              <a:t>12</a:t>
            </a:fld>
            <a:endParaRPr lang="en-IN"/>
          </a:p>
        </p:txBody>
      </p:sp>
      <p:sp>
        <p:nvSpPr>
          <p:cNvPr id="9" name="Rectangle 8"/>
          <p:cNvSpPr/>
          <p:nvPr/>
        </p:nvSpPr>
        <p:spPr>
          <a:xfrm>
            <a:off x="1224793" y="906011"/>
            <a:ext cx="9280174" cy="5519956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7" name="TextBox 6"/>
          <p:cNvSpPr txBox="1"/>
          <p:nvPr/>
        </p:nvSpPr>
        <p:spPr>
          <a:xfrm>
            <a:off x="4994376" y="345184"/>
            <a:ext cx="137409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0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usaMA2 </a:t>
            </a:r>
            <a:endParaRPr lang="en-IN" sz="20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9111429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44600" y="1082180"/>
            <a:ext cx="9048692" cy="5167617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4831071" y="505900"/>
            <a:ext cx="130997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usaMA2</a:t>
            </a:r>
            <a:endParaRPr lang="en-IN" sz="20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Slide Number Placeholder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05F05F-5AFD-4104-8603-F9D0AE6173F3}" type="slidenum">
              <a:rPr lang="en-IN" smtClean="0"/>
              <a:t>13</a:t>
            </a:fld>
            <a:endParaRPr lang="en-IN"/>
          </a:p>
        </p:txBody>
      </p:sp>
      <p:sp>
        <p:nvSpPr>
          <p:cNvPr id="7" name="Rectangle 6"/>
          <p:cNvSpPr/>
          <p:nvPr/>
        </p:nvSpPr>
        <p:spPr>
          <a:xfrm>
            <a:off x="1224793" y="906011"/>
            <a:ext cx="9280174" cy="5519956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4" name="Rectangle 3"/>
          <p:cNvSpPr/>
          <p:nvPr/>
        </p:nvSpPr>
        <p:spPr>
          <a:xfrm>
            <a:off x="3083813" y="1813154"/>
            <a:ext cx="4103496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IN" sz="16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soflavanone</a:t>
            </a:r>
            <a:r>
              <a:rPr lang="en-IN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–</a:t>
            </a:r>
            <a:r>
              <a:rPr lang="en-IN" sz="16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albergioidin</a:t>
            </a:r>
            <a:r>
              <a:rPr lang="en-IN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IN" sz="16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lored</a:t>
            </a:r>
            <a:r>
              <a:rPr lang="en-IN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pigment</a:t>
            </a:r>
            <a:endParaRPr lang="en-IN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0859584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65200" y="1092200"/>
            <a:ext cx="10198099" cy="5356224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4906681" y="545000"/>
            <a:ext cx="155523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usaMA2+TT8</a:t>
            </a:r>
            <a:endParaRPr lang="en-IN" sz="16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Rectangle 8"/>
          <p:cNvSpPr/>
          <p:nvPr/>
        </p:nvSpPr>
        <p:spPr>
          <a:xfrm>
            <a:off x="2854933" y="1570470"/>
            <a:ext cx="4103496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IN" sz="16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soflavanone</a:t>
            </a:r>
            <a:r>
              <a:rPr lang="en-IN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–</a:t>
            </a:r>
            <a:r>
              <a:rPr lang="en-IN" sz="16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albergioidin</a:t>
            </a:r>
            <a:r>
              <a:rPr lang="en-IN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IN" sz="16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lored</a:t>
            </a:r>
            <a:r>
              <a:rPr lang="en-IN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pigment</a:t>
            </a:r>
            <a:endParaRPr lang="en-IN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Slide Number Placeholder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05F05F-5AFD-4104-8603-F9D0AE6173F3}" type="slidenum">
              <a:rPr lang="en-IN" smtClean="0"/>
              <a:t>14</a:t>
            </a:fld>
            <a:endParaRPr lang="en-IN"/>
          </a:p>
        </p:txBody>
      </p:sp>
      <p:sp>
        <p:nvSpPr>
          <p:cNvPr id="6" name="Rectangle 5"/>
          <p:cNvSpPr/>
          <p:nvPr/>
        </p:nvSpPr>
        <p:spPr>
          <a:xfrm>
            <a:off x="855677" y="906011"/>
            <a:ext cx="10209402" cy="5519956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37860366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85091" y="960582"/>
            <a:ext cx="10141527" cy="5275118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2726679" y="1385906"/>
            <a:ext cx="20612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lavanols</a:t>
            </a:r>
            <a:r>
              <a:rPr lang="en-US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n-US" sz="16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Quercitin</a:t>
            </a:r>
            <a:r>
              <a:rPr lang="en-US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4787949" y="524072"/>
            <a:ext cx="16065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usaMA2+TT8</a:t>
            </a:r>
            <a:endParaRPr lang="en-IN" sz="16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05F05F-5AFD-4104-8603-F9D0AE6173F3}" type="slidenum">
              <a:rPr lang="en-IN" smtClean="0"/>
              <a:t>15</a:t>
            </a:fld>
            <a:endParaRPr lang="en-IN"/>
          </a:p>
        </p:txBody>
      </p:sp>
      <p:sp>
        <p:nvSpPr>
          <p:cNvPr id="6" name="Rectangle 5"/>
          <p:cNvSpPr/>
          <p:nvPr/>
        </p:nvSpPr>
        <p:spPr>
          <a:xfrm>
            <a:off x="906010" y="906011"/>
            <a:ext cx="10020607" cy="5519956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797837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96999" y="964734"/>
            <a:ext cx="9107967" cy="5532903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2759990" y="1162415"/>
            <a:ext cx="19502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oanthocyanidin</a:t>
            </a:r>
            <a:endParaRPr lang="en-IN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1943099" y="3699996"/>
            <a:ext cx="16337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eucocyanidin</a:t>
            </a:r>
            <a:endParaRPr lang="en-IN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4710204" y="496562"/>
            <a:ext cx="17267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usaMA2+TT8</a:t>
            </a:r>
            <a:endParaRPr lang="en-IN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Slide Number Placeholder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05F05F-5AFD-4104-8603-F9D0AE6173F3}" type="slidenum">
              <a:rPr lang="en-IN" smtClean="0"/>
              <a:t>16</a:t>
            </a:fld>
            <a:endParaRPr lang="en-IN"/>
          </a:p>
        </p:txBody>
      </p:sp>
      <p:sp>
        <p:nvSpPr>
          <p:cNvPr id="7" name="Rectangle 6"/>
          <p:cNvSpPr/>
          <p:nvPr/>
        </p:nvSpPr>
        <p:spPr>
          <a:xfrm>
            <a:off x="1224793" y="906011"/>
            <a:ext cx="9280174" cy="5519956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58313571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01699" y="660401"/>
            <a:ext cx="9678987" cy="5815224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2283588" y="895978"/>
            <a:ext cx="13003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lavonones</a:t>
            </a:r>
            <a:endParaRPr lang="en-IN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4559222" y="291069"/>
            <a:ext cx="17844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usaMA2+TT8</a:t>
            </a:r>
            <a:endParaRPr lang="en-IN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05F05F-5AFD-4104-8603-F9D0AE6173F3}" type="slidenum">
              <a:rPr lang="en-IN" smtClean="0"/>
              <a:t>17</a:t>
            </a:fld>
            <a:endParaRPr lang="en-IN"/>
          </a:p>
        </p:txBody>
      </p:sp>
      <p:sp>
        <p:nvSpPr>
          <p:cNvPr id="6" name="Rectangle 5"/>
          <p:cNvSpPr/>
          <p:nvPr/>
        </p:nvSpPr>
        <p:spPr>
          <a:xfrm>
            <a:off x="763398" y="660401"/>
            <a:ext cx="9741569" cy="5563114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754211317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Number Placeholder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05F05F-5AFD-4104-8603-F9D0AE6173F3}" type="slidenum">
              <a:rPr lang="en-IN" smtClean="0"/>
              <a:t>18</a:t>
            </a:fld>
            <a:endParaRPr lang="en-IN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55317" y="646257"/>
            <a:ext cx="9210675" cy="5553075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3509818" y="4054764"/>
            <a:ext cx="9650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 smtClean="0"/>
              <a:t>cyanidin</a:t>
            </a:r>
            <a:endParaRPr lang="en-IN" dirty="0"/>
          </a:p>
        </p:txBody>
      </p:sp>
      <p:sp>
        <p:nvSpPr>
          <p:cNvPr id="5" name="TextBox 4"/>
          <p:cNvSpPr txBox="1"/>
          <p:nvPr/>
        </p:nvSpPr>
        <p:spPr>
          <a:xfrm>
            <a:off x="4944738" y="525617"/>
            <a:ext cx="113685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usaMA4 </a:t>
            </a:r>
            <a:endParaRPr lang="en-IN" sz="16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14229576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4944738" y="525617"/>
            <a:ext cx="16065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usaMA4 +TT8</a:t>
            </a:r>
            <a:endParaRPr lang="en-IN" sz="16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91039" y="936788"/>
            <a:ext cx="9050583" cy="4766669"/>
          </a:xfrm>
          <a:prstGeom prst="rect">
            <a:avLst/>
          </a:prstGeom>
        </p:spPr>
      </p:pic>
      <p:sp>
        <p:nvSpPr>
          <p:cNvPr id="5" name="Rectangle 4"/>
          <p:cNvSpPr/>
          <p:nvPr/>
        </p:nvSpPr>
        <p:spPr>
          <a:xfrm>
            <a:off x="991039" y="5998682"/>
            <a:ext cx="2475358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IN" sz="1600" b="1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eonidin</a:t>
            </a:r>
            <a:r>
              <a:rPr lang="en-IN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IN" sz="16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IN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m/z = </a:t>
            </a:r>
            <a:r>
              <a:rPr lang="en-IN" sz="1600" b="1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340.358</a:t>
            </a:r>
            <a:r>
              <a:rPr lang="en-IN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IN" sz="1600" b="1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lang="en-IN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Rectangle 5"/>
          <p:cNvSpPr/>
          <p:nvPr/>
        </p:nvSpPr>
        <p:spPr>
          <a:xfrm>
            <a:off x="4166562" y="1359023"/>
            <a:ext cx="2082621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RODELPHINIDIN B4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IN" sz="1400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05F05F-5AFD-4104-8603-F9D0AE6173F3}" type="slidenum">
              <a:rPr lang="en-IN" smtClean="0"/>
              <a:t>19</a:t>
            </a:fld>
            <a:endParaRPr lang="en-IN"/>
          </a:p>
        </p:txBody>
      </p:sp>
      <p:sp>
        <p:nvSpPr>
          <p:cNvPr id="8" name="Rectangle 7"/>
          <p:cNvSpPr/>
          <p:nvPr/>
        </p:nvSpPr>
        <p:spPr>
          <a:xfrm>
            <a:off x="991039" y="906011"/>
            <a:ext cx="9513928" cy="4797446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98263991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Number Placeholder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05F05F-5AFD-4104-8603-F9D0AE6173F3}" type="slidenum">
              <a:rPr lang="en-IN" smtClean="0"/>
              <a:t>2</a:t>
            </a:fld>
            <a:endParaRPr lang="en-IN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64143" y="774404"/>
            <a:ext cx="10385358" cy="5581946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595" t="1" r="32917" b="-12343"/>
          <a:stretch/>
        </p:blipFill>
        <p:spPr>
          <a:xfrm>
            <a:off x="7566502" y="1143736"/>
            <a:ext cx="585050" cy="1558225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5229887" y="90090"/>
            <a:ext cx="125386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usaUP1</a:t>
            </a:r>
            <a:endParaRPr lang="en-IN" sz="20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Rectangle 5"/>
          <p:cNvSpPr/>
          <p:nvPr/>
        </p:nvSpPr>
        <p:spPr>
          <a:xfrm>
            <a:off x="7613583" y="2576833"/>
            <a:ext cx="490889" cy="4455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7" name="Rectangle 6"/>
          <p:cNvSpPr/>
          <p:nvPr/>
        </p:nvSpPr>
        <p:spPr>
          <a:xfrm>
            <a:off x="6439078" y="469260"/>
            <a:ext cx="264046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IN" b="1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eonidin</a:t>
            </a:r>
            <a:r>
              <a:rPr lang="en-IN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3,5-diglucoside</a:t>
            </a:r>
            <a:r>
              <a:rPr lang="en-I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IN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Rectangle 7"/>
          <p:cNvSpPr/>
          <p:nvPr/>
        </p:nvSpPr>
        <p:spPr>
          <a:xfrm>
            <a:off x="746620" y="469260"/>
            <a:ext cx="10302881" cy="5956707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70213015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4948977" y="397656"/>
            <a:ext cx="130997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usaMA8</a:t>
            </a:r>
            <a:endParaRPr lang="en-IN" sz="20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58679" y="912572"/>
            <a:ext cx="9526772" cy="5290344"/>
          </a:xfrm>
          <a:prstGeom prst="rect">
            <a:avLst/>
          </a:prstGeom>
        </p:spPr>
      </p:pic>
      <p:sp>
        <p:nvSpPr>
          <p:cNvPr id="4" name="Rectangle 3"/>
          <p:cNvSpPr/>
          <p:nvPr/>
        </p:nvSpPr>
        <p:spPr>
          <a:xfrm>
            <a:off x="2987749" y="3615070"/>
            <a:ext cx="3837397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IN" sz="1600" b="1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quercetin </a:t>
            </a:r>
            <a:r>
              <a:rPr lang="en-IN" sz="16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3-O-rhamnoside-7-O-glucoside</a:t>
            </a:r>
            <a:r>
              <a:rPr lang="en-IN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IN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Rectangle 4"/>
          <p:cNvSpPr/>
          <p:nvPr/>
        </p:nvSpPr>
        <p:spPr>
          <a:xfrm>
            <a:off x="3562096" y="1365778"/>
            <a:ext cx="1014508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IN" sz="1600" b="1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quercetin</a:t>
            </a:r>
            <a:endParaRPr lang="en-IN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05F05F-5AFD-4104-8603-F9D0AE6173F3}" type="slidenum">
              <a:rPr lang="en-IN" smtClean="0"/>
              <a:t>20</a:t>
            </a:fld>
            <a:endParaRPr lang="en-IN"/>
          </a:p>
        </p:txBody>
      </p:sp>
      <p:sp>
        <p:nvSpPr>
          <p:cNvPr id="7" name="Rectangle 6"/>
          <p:cNvSpPr/>
          <p:nvPr/>
        </p:nvSpPr>
        <p:spPr>
          <a:xfrm>
            <a:off x="1658679" y="855092"/>
            <a:ext cx="9526772" cy="5519956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756008048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5010157" y="479275"/>
            <a:ext cx="107593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A8+TT8</a:t>
            </a:r>
            <a:endParaRPr lang="en-IN" sz="16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61389" y="1012176"/>
            <a:ext cx="9521965" cy="5413791"/>
          </a:xfrm>
          <a:prstGeom prst="rect">
            <a:avLst/>
          </a:prstGeom>
        </p:spPr>
      </p:pic>
      <p:sp>
        <p:nvSpPr>
          <p:cNvPr id="4" name="Rectangle 3"/>
          <p:cNvSpPr/>
          <p:nvPr/>
        </p:nvSpPr>
        <p:spPr>
          <a:xfrm>
            <a:off x="4409542" y="1471007"/>
            <a:ext cx="1782860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400" b="1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RODELPHINIDIN</a:t>
            </a:r>
          </a:p>
          <a:p>
            <a:pPr algn="ctr"/>
            <a:r>
              <a:rPr lang="en-US" sz="1400" b="1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400" b="1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erivative</a:t>
            </a:r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IN" sz="1400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05F05F-5AFD-4104-8603-F9D0AE6173F3}" type="slidenum">
              <a:rPr lang="en-IN" smtClean="0"/>
              <a:t>21</a:t>
            </a:fld>
            <a:endParaRPr lang="en-IN"/>
          </a:p>
        </p:txBody>
      </p:sp>
      <p:sp>
        <p:nvSpPr>
          <p:cNvPr id="6" name="Rectangle 5"/>
          <p:cNvSpPr/>
          <p:nvPr/>
        </p:nvSpPr>
        <p:spPr>
          <a:xfrm>
            <a:off x="1022948" y="906011"/>
            <a:ext cx="9798849" cy="5519956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8" name="Rectangle 7"/>
          <p:cNvSpPr/>
          <p:nvPr/>
        </p:nvSpPr>
        <p:spPr>
          <a:xfrm>
            <a:off x="3687647" y="1583426"/>
            <a:ext cx="721895" cy="298383"/>
          </a:xfrm>
          <a:prstGeom prst="rect">
            <a:avLst/>
          </a:prstGeom>
          <a:noFill/>
          <a:ln w="38100">
            <a:solidFill>
              <a:srgbClr val="7030A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2430015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Number Placeholder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05F05F-5AFD-4104-8603-F9D0AE6173F3}" type="slidenum">
              <a:rPr lang="en-IN" smtClean="0"/>
              <a:t>3</a:t>
            </a:fld>
            <a:endParaRPr lang="en-IN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55807" y="1093410"/>
            <a:ext cx="10400185" cy="5384232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243" t="1683" r="34787" b="6531"/>
          <a:stretch/>
        </p:blipFill>
        <p:spPr>
          <a:xfrm>
            <a:off x="8064636" y="1244029"/>
            <a:ext cx="545964" cy="1055956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5480240" y="415392"/>
            <a:ext cx="131799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usaUP2 </a:t>
            </a:r>
            <a:endParaRPr lang="en-IN" sz="20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Rectangle 5"/>
          <p:cNvSpPr/>
          <p:nvPr/>
        </p:nvSpPr>
        <p:spPr>
          <a:xfrm>
            <a:off x="7093595" y="845369"/>
            <a:ext cx="264046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IN" b="1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eonidin</a:t>
            </a:r>
            <a:r>
              <a:rPr lang="en-IN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3,5-diglucoside</a:t>
            </a:r>
            <a:r>
              <a:rPr lang="en-I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IN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Rectangle 6"/>
          <p:cNvSpPr/>
          <p:nvPr/>
        </p:nvSpPr>
        <p:spPr>
          <a:xfrm>
            <a:off x="8140310" y="2348564"/>
            <a:ext cx="470290" cy="46201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8" name="Rectangle 7"/>
          <p:cNvSpPr/>
          <p:nvPr/>
        </p:nvSpPr>
        <p:spPr>
          <a:xfrm>
            <a:off x="1163421" y="845369"/>
            <a:ext cx="10302881" cy="5580598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15402565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5120135" y="585853"/>
            <a:ext cx="125386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0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usaUP1</a:t>
            </a:r>
            <a:endParaRPr lang="en-IN" sz="20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24748" y="1073791"/>
            <a:ext cx="10472724" cy="5529078"/>
          </a:xfrm>
          <a:prstGeom prst="rect">
            <a:avLst/>
          </a:prstGeom>
        </p:spPr>
      </p:pic>
      <p:sp>
        <p:nvSpPr>
          <p:cNvPr id="4" name="Rectangle 3"/>
          <p:cNvSpPr/>
          <p:nvPr/>
        </p:nvSpPr>
        <p:spPr>
          <a:xfrm>
            <a:off x="6525174" y="1327300"/>
            <a:ext cx="264046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IN" b="1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eonidin</a:t>
            </a:r>
            <a:r>
              <a:rPr lang="en-IN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3,5-diglucoside</a:t>
            </a:r>
            <a:r>
              <a:rPr lang="en-I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IN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05F05F-5AFD-4104-8603-F9D0AE6173F3}" type="slidenum">
              <a:rPr lang="en-IN" smtClean="0"/>
              <a:t>4</a:t>
            </a:fld>
            <a:endParaRPr lang="en-IN" dirty="0"/>
          </a:p>
        </p:txBody>
      </p:sp>
      <p:sp>
        <p:nvSpPr>
          <p:cNvPr id="6" name="Rectangle 5"/>
          <p:cNvSpPr/>
          <p:nvPr/>
        </p:nvSpPr>
        <p:spPr>
          <a:xfrm>
            <a:off x="233916" y="955185"/>
            <a:ext cx="10815585" cy="5470782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41129024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Number Placeholder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05F05F-5AFD-4104-8603-F9D0AE6173F3}" type="slidenum">
              <a:rPr lang="en-IN" smtClean="0"/>
              <a:t>5</a:t>
            </a:fld>
            <a:endParaRPr lang="en-IN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66800" y="935037"/>
            <a:ext cx="9080500" cy="5304060"/>
          </a:xfrm>
          <a:prstGeom prst="rect">
            <a:avLst/>
          </a:prstGeom>
        </p:spPr>
      </p:pic>
      <p:sp>
        <p:nvSpPr>
          <p:cNvPr id="4" name="Rectangle 3"/>
          <p:cNvSpPr/>
          <p:nvPr/>
        </p:nvSpPr>
        <p:spPr>
          <a:xfrm>
            <a:off x="7632700" y="1066800"/>
            <a:ext cx="812800" cy="3683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167" t="4445" r="47500"/>
          <a:stretch/>
        </p:blipFill>
        <p:spPr>
          <a:xfrm>
            <a:off x="6835968" y="652583"/>
            <a:ext cx="522986" cy="1196733"/>
          </a:xfrm>
          <a:prstGeom prst="rect">
            <a:avLst/>
          </a:prstGeom>
        </p:spPr>
      </p:pic>
      <p:sp>
        <p:nvSpPr>
          <p:cNvPr id="7" name="Rectangle 6"/>
          <p:cNvSpPr/>
          <p:nvPr/>
        </p:nvSpPr>
        <p:spPr>
          <a:xfrm>
            <a:off x="7533192" y="708184"/>
            <a:ext cx="1011815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IN" sz="1600" b="1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eonidin</a:t>
            </a:r>
            <a:r>
              <a:rPr lang="en-IN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IN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4561368" y="245568"/>
            <a:ext cx="154241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usaUP1+TT8</a:t>
            </a:r>
            <a:endParaRPr lang="en-IN" sz="16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Rectangle 8"/>
          <p:cNvSpPr/>
          <p:nvPr/>
        </p:nvSpPr>
        <p:spPr>
          <a:xfrm>
            <a:off x="1066801" y="605287"/>
            <a:ext cx="9080500" cy="5560621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88235405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Number Placeholder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05F05F-5AFD-4104-8603-F9D0AE6173F3}" type="slidenum">
              <a:rPr lang="en-IN" smtClean="0"/>
              <a:t>6</a:t>
            </a:fld>
            <a:endParaRPr lang="en-IN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67599" y="841374"/>
            <a:ext cx="10111526" cy="5697538"/>
          </a:xfrm>
          <a:prstGeom prst="rect">
            <a:avLst/>
          </a:prstGeom>
        </p:spPr>
      </p:pic>
      <p:sp>
        <p:nvSpPr>
          <p:cNvPr id="4" name="Rectangle 3"/>
          <p:cNvSpPr/>
          <p:nvPr/>
        </p:nvSpPr>
        <p:spPr>
          <a:xfrm>
            <a:off x="7454900" y="1981200"/>
            <a:ext cx="622300" cy="3556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5" name="Rectangle 4"/>
          <p:cNvSpPr/>
          <p:nvPr/>
        </p:nvSpPr>
        <p:spPr>
          <a:xfrm>
            <a:off x="8077200" y="939800"/>
            <a:ext cx="635000" cy="4064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6" name="TextBox 5"/>
          <p:cNvSpPr txBox="1"/>
          <p:nvPr/>
        </p:nvSpPr>
        <p:spPr>
          <a:xfrm>
            <a:off x="4797624" y="186248"/>
            <a:ext cx="154241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usaUP2+TT8</a:t>
            </a:r>
            <a:endParaRPr lang="en-IN" sz="16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Rectangle 6"/>
          <p:cNvSpPr/>
          <p:nvPr/>
        </p:nvSpPr>
        <p:spPr>
          <a:xfrm>
            <a:off x="7888792" y="573356"/>
            <a:ext cx="1011815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IN" sz="1600" b="1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eonidin</a:t>
            </a:r>
            <a:r>
              <a:rPr lang="en-IN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IN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446" t="29260" r="17777" b="29259"/>
          <a:stretch/>
        </p:blipFill>
        <p:spPr>
          <a:xfrm rot="5400000">
            <a:off x="6889000" y="959457"/>
            <a:ext cx="1227051" cy="548418"/>
          </a:xfrm>
          <a:prstGeom prst="rect">
            <a:avLst/>
          </a:prstGeom>
        </p:spPr>
      </p:pic>
      <p:sp>
        <p:nvSpPr>
          <p:cNvPr id="9" name="Rectangle 8"/>
          <p:cNvSpPr/>
          <p:nvPr/>
        </p:nvSpPr>
        <p:spPr>
          <a:xfrm>
            <a:off x="6093630" y="2068426"/>
            <a:ext cx="1394934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IN" sz="16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IN" sz="16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lbergioidin</a:t>
            </a:r>
            <a:endParaRPr lang="en-IN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Rectangle 9"/>
          <p:cNvSpPr/>
          <p:nvPr/>
        </p:nvSpPr>
        <p:spPr>
          <a:xfrm>
            <a:off x="746620" y="538088"/>
            <a:ext cx="9815119" cy="5874762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70667148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4919064" y="595777"/>
            <a:ext cx="154241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usaUP1+TT8</a:t>
            </a:r>
            <a:endParaRPr lang="en-IN" sz="16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29192" y="1040882"/>
            <a:ext cx="9311979" cy="5103129"/>
          </a:xfrm>
          <a:prstGeom prst="rect">
            <a:avLst/>
          </a:prstGeom>
        </p:spPr>
      </p:pic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05F05F-5AFD-4104-8603-F9D0AE6173F3}" type="slidenum">
              <a:rPr lang="en-IN" smtClean="0"/>
              <a:t>7</a:t>
            </a:fld>
            <a:endParaRPr lang="en-IN"/>
          </a:p>
        </p:txBody>
      </p:sp>
      <p:sp>
        <p:nvSpPr>
          <p:cNvPr id="6" name="Rectangle 5"/>
          <p:cNvSpPr/>
          <p:nvPr/>
        </p:nvSpPr>
        <p:spPr>
          <a:xfrm>
            <a:off x="1129192" y="1040883"/>
            <a:ext cx="9122155" cy="5208916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3" name="Rectangle 2"/>
          <p:cNvSpPr/>
          <p:nvPr/>
        </p:nvSpPr>
        <p:spPr>
          <a:xfrm>
            <a:off x="2083801" y="1202552"/>
            <a:ext cx="1011815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IN" sz="1600" b="1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eonidin</a:t>
            </a:r>
            <a:r>
              <a:rPr lang="en-IN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IN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541204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Number Placeholder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05F05F-5AFD-4104-8603-F9D0AE6173F3}" type="slidenum">
              <a:rPr lang="en-IN" smtClean="0"/>
              <a:t>8</a:t>
            </a:fld>
            <a:endParaRPr lang="en-IN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61823" y="791175"/>
            <a:ext cx="9604921" cy="5450138"/>
          </a:xfrm>
          <a:prstGeom prst="rect">
            <a:avLst/>
          </a:prstGeom>
        </p:spPr>
      </p:pic>
      <p:sp>
        <p:nvSpPr>
          <p:cNvPr id="4" name="Rectangle 3"/>
          <p:cNvSpPr/>
          <p:nvPr/>
        </p:nvSpPr>
        <p:spPr>
          <a:xfrm>
            <a:off x="2755007" y="1260351"/>
            <a:ext cx="2582758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IN" sz="16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soflavanone-Dalbergioidin</a:t>
            </a:r>
            <a:endParaRPr lang="en-IN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Rectangle 4"/>
          <p:cNvSpPr/>
          <p:nvPr/>
        </p:nvSpPr>
        <p:spPr>
          <a:xfrm>
            <a:off x="746620" y="551205"/>
            <a:ext cx="9815119" cy="5874762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6" name="TextBox 5"/>
          <p:cNvSpPr txBox="1"/>
          <p:nvPr/>
        </p:nvSpPr>
        <p:spPr>
          <a:xfrm>
            <a:off x="4793078" y="212651"/>
            <a:ext cx="154241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usaUP2+TT8</a:t>
            </a:r>
            <a:endParaRPr lang="en-IN" sz="16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2176440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Number Placeholder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05F05F-5AFD-4104-8603-F9D0AE6173F3}" type="slidenum">
              <a:rPr lang="en-IN" smtClean="0"/>
              <a:t>9</a:t>
            </a:fld>
            <a:endParaRPr lang="en-IN"/>
          </a:p>
        </p:txBody>
      </p:sp>
      <p:sp>
        <p:nvSpPr>
          <p:cNvPr id="5" name="Rectangle 4"/>
          <p:cNvSpPr/>
          <p:nvPr/>
        </p:nvSpPr>
        <p:spPr>
          <a:xfrm>
            <a:off x="1604105" y="1052623"/>
            <a:ext cx="8957634" cy="5373344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80921" y="1286541"/>
            <a:ext cx="8204001" cy="5069810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914398" y="467782"/>
            <a:ext cx="2565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asthali</a:t>
            </a:r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Control (Plant)</a:t>
            </a:r>
            <a:endParaRPr lang="en-IN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283897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28</TotalTime>
  <Words>103</Words>
  <Application>Microsoft Office PowerPoint</Application>
  <PresentationFormat>Widescreen</PresentationFormat>
  <Paragraphs>67</Paragraphs>
  <Slides>2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1</vt:i4>
      </vt:variant>
    </vt:vector>
  </HeadingPairs>
  <TitlesOfParts>
    <vt:vector size="26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P</dc:creator>
  <cp:lastModifiedBy>Nandita</cp:lastModifiedBy>
  <cp:revision>48</cp:revision>
  <dcterms:created xsi:type="dcterms:W3CDTF">2025-08-12T08:55:13Z</dcterms:created>
  <dcterms:modified xsi:type="dcterms:W3CDTF">2025-11-26T11:06:41Z</dcterms:modified>
</cp:coreProperties>
</file>